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70138" autoAdjust="0"/>
  </p:normalViewPr>
  <p:slideViewPr>
    <p:cSldViewPr snapToGrid="0">
      <p:cViewPr varScale="1">
        <p:scale>
          <a:sx n="57" d="100"/>
          <a:sy n="57" d="100"/>
        </p:scale>
        <p:origin x="3558" y="7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31591B8-81F9-4559-A323-4206C9CC0EEE}" type="datetimeFigureOut">
              <a:rPr lang="fr-FR" smtClean="0"/>
              <a:t>20/08/2020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FED0FD1-9DAE-452D-B8FC-E887C977715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337874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FED0FD1-9DAE-452D-B8FC-E887C9777154}" type="slidenum">
              <a:rPr lang="fr-FR" smtClean="0"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617888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B11217-0F99-428F-87F3-8CD58DD4CBBA}" type="datetimeFigureOut">
              <a:rPr lang="fr-FR" smtClean="0"/>
              <a:t>20/08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A5B403-7B6C-46BA-882C-055EBA8FA00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930340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B11217-0F99-428F-87F3-8CD58DD4CBBA}" type="datetimeFigureOut">
              <a:rPr lang="fr-FR" smtClean="0"/>
              <a:t>20/08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A5B403-7B6C-46BA-882C-055EBA8FA00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206273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B11217-0F99-428F-87F3-8CD58DD4CBBA}" type="datetimeFigureOut">
              <a:rPr lang="fr-FR" smtClean="0"/>
              <a:t>20/08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A5B403-7B6C-46BA-882C-055EBA8FA00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210571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B11217-0F99-428F-87F3-8CD58DD4CBBA}" type="datetimeFigureOut">
              <a:rPr lang="fr-FR" smtClean="0"/>
              <a:t>20/08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A5B403-7B6C-46BA-882C-055EBA8FA00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750662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B11217-0F99-428F-87F3-8CD58DD4CBBA}" type="datetimeFigureOut">
              <a:rPr lang="fr-FR" smtClean="0"/>
              <a:t>20/08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A5B403-7B6C-46BA-882C-055EBA8FA00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091717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B11217-0F99-428F-87F3-8CD58DD4CBBA}" type="datetimeFigureOut">
              <a:rPr lang="fr-FR" smtClean="0"/>
              <a:t>20/08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A5B403-7B6C-46BA-882C-055EBA8FA00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361448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B11217-0F99-428F-87F3-8CD58DD4CBBA}" type="datetimeFigureOut">
              <a:rPr lang="fr-FR" smtClean="0"/>
              <a:t>20/08/2020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A5B403-7B6C-46BA-882C-055EBA8FA00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636991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B11217-0F99-428F-87F3-8CD58DD4CBBA}" type="datetimeFigureOut">
              <a:rPr lang="fr-FR" smtClean="0"/>
              <a:t>20/08/2020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A5B403-7B6C-46BA-882C-055EBA8FA00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024750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B11217-0F99-428F-87F3-8CD58DD4CBBA}" type="datetimeFigureOut">
              <a:rPr lang="fr-FR" smtClean="0"/>
              <a:t>20/08/2020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A5B403-7B6C-46BA-882C-055EBA8FA00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517221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B11217-0F99-428F-87F3-8CD58DD4CBBA}" type="datetimeFigureOut">
              <a:rPr lang="fr-FR" smtClean="0"/>
              <a:t>20/08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A5B403-7B6C-46BA-882C-055EBA8FA00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850824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B11217-0F99-428F-87F3-8CD58DD4CBBA}" type="datetimeFigureOut">
              <a:rPr lang="fr-FR" smtClean="0"/>
              <a:t>20/08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A5B403-7B6C-46BA-882C-055EBA8FA00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433612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B11217-0F99-428F-87F3-8CD58DD4CBBA}" type="datetimeFigureOut">
              <a:rPr lang="fr-FR" smtClean="0"/>
              <a:t>20/08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A5B403-7B6C-46BA-882C-055EBA8FA00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525394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au 4">
            <a:extLst>
              <a:ext uri="{FF2B5EF4-FFF2-40B4-BE49-F238E27FC236}">
                <a16:creationId xmlns:a16="http://schemas.microsoft.com/office/drawing/2014/main" id="{F0934EE3-12BD-4633-B74D-56A9DEBB81F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04455688"/>
              </p:ext>
            </p:extLst>
          </p:nvPr>
        </p:nvGraphicFramePr>
        <p:xfrm>
          <a:off x="259553" y="2279458"/>
          <a:ext cx="6338893" cy="2259798"/>
        </p:xfrm>
        <a:graphic>
          <a:graphicData uri="http://schemas.openxmlformats.org/drawingml/2006/table">
            <a:tbl>
              <a:tblPr/>
              <a:tblGrid>
                <a:gridCol w="576263">
                  <a:extLst>
                    <a:ext uri="{9D8B030D-6E8A-4147-A177-3AD203B41FA5}">
                      <a16:colId xmlns:a16="http://schemas.microsoft.com/office/drawing/2014/main" val="2870109446"/>
                    </a:ext>
                  </a:extLst>
                </a:gridCol>
                <a:gridCol w="576263">
                  <a:extLst>
                    <a:ext uri="{9D8B030D-6E8A-4147-A177-3AD203B41FA5}">
                      <a16:colId xmlns:a16="http://schemas.microsoft.com/office/drawing/2014/main" val="1260801835"/>
                    </a:ext>
                  </a:extLst>
                </a:gridCol>
                <a:gridCol w="576263">
                  <a:extLst>
                    <a:ext uri="{9D8B030D-6E8A-4147-A177-3AD203B41FA5}">
                      <a16:colId xmlns:a16="http://schemas.microsoft.com/office/drawing/2014/main" val="2241654567"/>
                    </a:ext>
                  </a:extLst>
                </a:gridCol>
                <a:gridCol w="576263">
                  <a:extLst>
                    <a:ext uri="{9D8B030D-6E8A-4147-A177-3AD203B41FA5}">
                      <a16:colId xmlns:a16="http://schemas.microsoft.com/office/drawing/2014/main" val="3205192652"/>
                    </a:ext>
                  </a:extLst>
                </a:gridCol>
                <a:gridCol w="576263">
                  <a:extLst>
                    <a:ext uri="{9D8B030D-6E8A-4147-A177-3AD203B41FA5}">
                      <a16:colId xmlns:a16="http://schemas.microsoft.com/office/drawing/2014/main" val="2051717671"/>
                    </a:ext>
                  </a:extLst>
                </a:gridCol>
                <a:gridCol w="576263">
                  <a:extLst>
                    <a:ext uri="{9D8B030D-6E8A-4147-A177-3AD203B41FA5}">
                      <a16:colId xmlns:a16="http://schemas.microsoft.com/office/drawing/2014/main" val="562804158"/>
                    </a:ext>
                  </a:extLst>
                </a:gridCol>
                <a:gridCol w="576263">
                  <a:extLst>
                    <a:ext uri="{9D8B030D-6E8A-4147-A177-3AD203B41FA5}">
                      <a16:colId xmlns:a16="http://schemas.microsoft.com/office/drawing/2014/main" val="2162004059"/>
                    </a:ext>
                  </a:extLst>
                </a:gridCol>
                <a:gridCol w="576263">
                  <a:extLst>
                    <a:ext uri="{9D8B030D-6E8A-4147-A177-3AD203B41FA5}">
                      <a16:colId xmlns:a16="http://schemas.microsoft.com/office/drawing/2014/main" val="1583509039"/>
                    </a:ext>
                  </a:extLst>
                </a:gridCol>
                <a:gridCol w="576263">
                  <a:extLst>
                    <a:ext uri="{9D8B030D-6E8A-4147-A177-3AD203B41FA5}">
                      <a16:colId xmlns:a16="http://schemas.microsoft.com/office/drawing/2014/main" val="830035717"/>
                    </a:ext>
                  </a:extLst>
                </a:gridCol>
                <a:gridCol w="576263">
                  <a:extLst>
                    <a:ext uri="{9D8B030D-6E8A-4147-A177-3AD203B41FA5}">
                      <a16:colId xmlns:a16="http://schemas.microsoft.com/office/drawing/2014/main" val="990146741"/>
                    </a:ext>
                  </a:extLst>
                </a:gridCol>
                <a:gridCol w="576263">
                  <a:extLst>
                    <a:ext uri="{9D8B030D-6E8A-4147-A177-3AD203B41FA5}">
                      <a16:colId xmlns:a16="http://schemas.microsoft.com/office/drawing/2014/main" val="27479525"/>
                    </a:ext>
                  </a:extLst>
                </a:gridCol>
              </a:tblGrid>
              <a:tr h="158715">
                <a:tc rowSpan="2" gridSpan="2">
                  <a:txBody>
                    <a:bodyPr/>
                    <a:lstStyle/>
                    <a:p>
                      <a:pPr algn="ctr" rtl="0" fontAlgn="ctr"/>
                      <a:r>
                        <a:rPr lang="fr-F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722" marR="6722" marT="6722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fr-FR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nome occupancy</a:t>
                      </a:r>
                    </a:p>
                  </a:txBody>
                  <a:tcPr marL="6722" marR="6722" marT="672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fr-FR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eaks detected</a:t>
                      </a:r>
                    </a:p>
                  </a:txBody>
                  <a:tcPr marL="6722" marR="6722" marT="672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fr-FR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eaks size</a:t>
                      </a:r>
                    </a:p>
                  </a:txBody>
                  <a:tcPr marL="6722" marR="6722" marT="672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rtl="0" fontAlgn="ctr"/>
                      <a:r>
                        <a:rPr lang="fr-FR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rked features</a:t>
                      </a:r>
                    </a:p>
                  </a:txBody>
                  <a:tcPr marL="6722" marR="6722" marT="672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95257041"/>
                  </a:ext>
                </a:extLst>
              </a:tr>
              <a:tr h="249409">
                <a:tc gridSpan="2"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b</a:t>
                      </a:r>
                    </a:p>
                  </a:txBody>
                  <a:tcPr marL="6722" marR="6722" marT="672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nome %</a:t>
                      </a:r>
                    </a:p>
                  </a:txBody>
                  <a:tcPr marL="6722" marR="6722" marT="672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otal</a:t>
                      </a:r>
                    </a:p>
                  </a:txBody>
                  <a:tcPr marL="6722" marR="6722" marT="672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T %</a:t>
                      </a:r>
                    </a:p>
                  </a:txBody>
                  <a:tcPr marL="6722" marR="6722" marT="672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verage</a:t>
                      </a:r>
                    </a:p>
                  </a:txBody>
                  <a:tcPr marL="6722" marR="6722" marT="672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T %</a:t>
                      </a:r>
                    </a:p>
                  </a:txBody>
                  <a:tcPr marL="6722" marR="6722" marT="672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nes</a:t>
                      </a:r>
                    </a:p>
                  </a:txBody>
                  <a:tcPr marL="6722" marR="6722" marT="672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peats</a:t>
                      </a:r>
                    </a:p>
                  </a:txBody>
                  <a:tcPr marL="6722" marR="6722" marT="672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peats in CDS</a:t>
                      </a:r>
                    </a:p>
                  </a:txBody>
                  <a:tcPr marL="6722" marR="6722" marT="672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74258909"/>
                  </a:ext>
                </a:extLst>
              </a:tr>
              <a:tr h="151157"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fr-FR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3K4me3</a:t>
                      </a:r>
                    </a:p>
                  </a:txBody>
                  <a:tcPr marL="6722" marR="6722" marT="672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E0B4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6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T</a:t>
                      </a:r>
                    </a:p>
                  </a:txBody>
                  <a:tcPr marL="6722" marR="6722" marT="672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E0B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    3,84 </a:t>
                      </a:r>
                    </a:p>
                  </a:txBody>
                  <a:tcPr marL="6722" marR="6722" marT="672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DB47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  10,98 </a:t>
                      </a:r>
                    </a:p>
                  </a:txBody>
                  <a:tcPr marL="6722" marR="6722" marT="672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DB47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3 050,00 </a:t>
                      </a:r>
                    </a:p>
                  </a:txBody>
                  <a:tcPr marL="6722" marR="6722" marT="672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827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100,00 </a:t>
                      </a:r>
                    </a:p>
                  </a:txBody>
                  <a:tcPr marL="6722" marR="6722" marT="672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AA7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1 259,52 </a:t>
                      </a:r>
                    </a:p>
                  </a:txBody>
                  <a:tcPr marL="6722" marR="6722" marT="672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88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100,00 </a:t>
                      </a:r>
                    </a:p>
                  </a:txBody>
                  <a:tcPr marL="6722" marR="6722" marT="672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28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3 503,00 </a:t>
                      </a:r>
                    </a:p>
                  </a:txBody>
                  <a:tcPr marL="6722" marR="6722" marT="672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7F7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  63,00 </a:t>
                      </a:r>
                    </a:p>
                  </a:txBody>
                  <a:tcPr marL="6722" marR="6722" marT="672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ED88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  49,00 </a:t>
                      </a:r>
                    </a:p>
                  </a:txBody>
                  <a:tcPr marL="6722" marR="6722" marT="672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BE08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34187434"/>
                  </a:ext>
                </a:extLst>
              </a:tr>
              <a:tr h="151157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l-GR" sz="6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Δ</a:t>
                      </a:r>
                      <a:r>
                        <a:rPr lang="fr-FR" sz="6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aHP1</a:t>
                      </a:r>
                    </a:p>
                  </a:txBody>
                  <a:tcPr marL="6722" marR="6722" marT="672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E0B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    3,66 </a:t>
                      </a:r>
                    </a:p>
                  </a:txBody>
                  <a:tcPr marL="6722" marR="6722" marT="672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DB97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  10,47 </a:t>
                      </a:r>
                    </a:p>
                  </a:txBody>
                  <a:tcPr marL="6722" marR="6722" marT="672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DB97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3 138,00 </a:t>
                      </a:r>
                    </a:p>
                  </a:txBody>
                  <a:tcPr marL="6722" marR="6722" marT="672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7C6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102,89 </a:t>
                      </a:r>
                    </a:p>
                  </a:txBody>
                  <a:tcPr marL="6722" marR="6722" marT="672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9B7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1 167,59 </a:t>
                      </a:r>
                    </a:p>
                  </a:txBody>
                  <a:tcPr marL="6722" marR="6722" marT="672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E98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  92,70 </a:t>
                      </a:r>
                    </a:p>
                  </a:txBody>
                  <a:tcPr marL="6722" marR="6722" marT="672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E98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3 587,00 </a:t>
                      </a:r>
                    </a:p>
                  </a:txBody>
                  <a:tcPr marL="6722" marR="6722" marT="672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7B6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  64,00 </a:t>
                      </a:r>
                    </a:p>
                  </a:txBody>
                  <a:tcPr marL="6722" marR="6722" marT="672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D88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  52,00 </a:t>
                      </a:r>
                    </a:p>
                  </a:txBody>
                  <a:tcPr marL="6722" marR="6722" marT="672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2E28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28800035"/>
                  </a:ext>
                </a:extLst>
              </a:tr>
              <a:tr h="151157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l-GR" sz="6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Δ</a:t>
                      </a:r>
                      <a:r>
                        <a:rPr lang="fr-FR" sz="6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aKmt1</a:t>
                      </a:r>
                    </a:p>
                  </a:txBody>
                  <a:tcPr marL="6722" marR="6722" marT="672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E0B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    4,15 </a:t>
                      </a:r>
                    </a:p>
                  </a:txBody>
                  <a:tcPr marL="6722" marR="6722" marT="672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AC7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  11,85 </a:t>
                      </a:r>
                    </a:p>
                  </a:txBody>
                  <a:tcPr marL="6722" marR="6722" marT="672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AC7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3 307,00 </a:t>
                      </a:r>
                    </a:p>
                  </a:txBody>
                  <a:tcPr marL="6722" marR="6722" marT="672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716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108,43 </a:t>
                      </a:r>
                    </a:p>
                  </a:txBody>
                  <a:tcPr marL="6722" marR="6722" marT="672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7F7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1 253,66 </a:t>
                      </a:r>
                    </a:p>
                  </a:txBody>
                  <a:tcPr marL="6722" marR="6722" marT="672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88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  99,53 </a:t>
                      </a:r>
                    </a:p>
                  </a:txBody>
                  <a:tcPr marL="6722" marR="6722" marT="672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8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3 793,00 </a:t>
                      </a:r>
                    </a:p>
                  </a:txBody>
                  <a:tcPr marL="6722" marR="6722" marT="672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726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  67,00 </a:t>
                      </a:r>
                    </a:p>
                  </a:txBody>
                  <a:tcPr marL="6722" marR="6722" marT="672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4DA8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  58,00 </a:t>
                      </a:r>
                    </a:p>
                  </a:txBody>
                  <a:tcPr marL="6722" marR="6722" marT="672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1E78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21687384"/>
                  </a:ext>
                </a:extLst>
              </a:tr>
              <a:tr h="15871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l-GR" sz="6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Δ</a:t>
                      </a:r>
                      <a:r>
                        <a:rPr lang="fr-FR" sz="6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aKMT6</a:t>
                      </a:r>
                    </a:p>
                  </a:txBody>
                  <a:tcPr marL="6722" marR="6722" marT="672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E0B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    4,19 </a:t>
                      </a:r>
                    </a:p>
                  </a:txBody>
                  <a:tcPr marL="6722" marR="6722" marT="672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AB7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  11,98 </a:t>
                      </a:r>
                    </a:p>
                  </a:txBody>
                  <a:tcPr marL="6722" marR="6722" marT="672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AB7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3 433,00 </a:t>
                      </a:r>
                    </a:p>
                  </a:txBody>
                  <a:tcPr marL="6722" marR="6722" marT="672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696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112,56 </a:t>
                      </a:r>
                    </a:p>
                  </a:txBody>
                  <a:tcPr marL="6722" marR="6722" marT="672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696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1 220,96 </a:t>
                      </a:r>
                    </a:p>
                  </a:txBody>
                  <a:tcPr marL="6722" marR="6722" marT="672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A8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  96,94 </a:t>
                      </a:r>
                    </a:p>
                  </a:txBody>
                  <a:tcPr marL="6722" marR="6722" marT="672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88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3 983,00 </a:t>
                      </a:r>
                    </a:p>
                  </a:txBody>
                  <a:tcPr marL="6722" marR="6722" marT="672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696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  85,00 </a:t>
                      </a:r>
                    </a:p>
                  </a:txBody>
                  <a:tcPr marL="6722" marR="6722" marT="672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EE18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  69,00 </a:t>
                      </a:r>
                    </a:p>
                  </a:txBody>
                  <a:tcPr marL="6722" marR="6722" marT="672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98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46734113"/>
                  </a:ext>
                </a:extLst>
              </a:tr>
              <a:tr h="158715"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fr-FR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3K9me3</a:t>
                      </a:r>
                    </a:p>
                  </a:txBody>
                  <a:tcPr marL="6722" marR="6722" marT="672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18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6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T</a:t>
                      </a:r>
                    </a:p>
                  </a:txBody>
                  <a:tcPr marL="6722" marR="6722" marT="672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18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    1,03 </a:t>
                      </a:r>
                    </a:p>
                  </a:txBody>
                  <a:tcPr marL="6722" marR="6722" marT="672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D98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    2,94 </a:t>
                      </a:r>
                    </a:p>
                  </a:txBody>
                  <a:tcPr marL="6722" marR="6722" marT="672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D98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1 090,00 </a:t>
                      </a:r>
                    </a:p>
                  </a:txBody>
                  <a:tcPr marL="6722" marR="6722" marT="672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E18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100,00 </a:t>
                      </a:r>
                    </a:p>
                  </a:txBody>
                  <a:tcPr marL="6722" marR="6722" marT="672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AA7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945,03 </a:t>
                      </a:r>
                    </a:p>
                  </a:txBody>
                  <a:tcPr marL="6722" marR="6722" marT="672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EE18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100,00 </a:t>
                      </a:r>
                    </a:p>
                  </a:txBody>
                  <a:tcPr marL="6722" marR="6722" marT="672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28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537,00 </a:t>
                      </a:r>
                    </a:p>
                  </a:txBody>
                  <a:tcPr marL="6722" marR="6722" marT="672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5D57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728,00 </a:t>
                      </a:r>
                    </a:p>
                  </a:txBody>
                  <a:tcPr marL="6722" marR="6722" marT="672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957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213,00 </a:t>
                      </a:r>
                    </a:p>
                  </a:txBody>
                  <a:tcPr marL="6722" marR="6722" marT="672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9C7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72786722"/>
                  </a:ext>
                </a:extLst>
              </a:tr>
              <a:tr h="151157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l-GR" sz="6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Δ</a:t>
                      </a:r>
                      <a:r>
                        <a:rPr lang="fr-FR" sz="6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aHP1</a:t>
                      </a:r>
                    </a:p>
                  </a:txBody>
                  <a:tcPr marL="6722" marR="6722" marT="672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18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    0,66 </a:t>
                      </a:r>
                    </a:p>
                  </a:txBody>
                  <a:tcPr marL="6722" marR="6722" marT="672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0CF7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    1,88 </a:t>
                      </a:r>
                    </a:p>
                  </a:txBody>
                  <a:tcPr marL="6722" marR="6722" marT="672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0CF7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419,00 </a:t>
                      </a:r>
                    </a:p>
                  </a:txBody>
                  <a:tcPr marL="6722" marR="6722" marT="672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CB7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  38,44 </a:t>
                      </a:r>
                    </a:p>
                  </a:txBody>
                  <a:tcPr marL="6722" marR="6722" marT="672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7D17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1 571,95 </a:t>
                      </a:r>
                    </a:p>
                  </a:txBody>
                  <a:tcPr marL="6722" marR="6722" marT="672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ED68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166,34 </a:t>
                      </a:r>
                    </a:p>
                  </a:txBody>
                  <a:tcPr marL="6722" marR="6722" marT="672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696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  93,00 </a:t>
                      </a:r>
                    </a:p>
                  </a:txBody>
                  <a:tcPr marL="6722" marR="6722" marT="672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1C27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861,00 </a:t>
                      </a:r>
                    </a:p>
                  </a:txBody>
                  <a:tcPr marL="6722" marR="6722" marT="672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837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  71,00 </a:t>
                      </a:r>
                    </a:p>
                  </a:txBody>
                  <a:tcPr marL="6722" marR="6722" marT="672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78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33254847"/>
                  </a:ext>
                </a:extLst>
              </a:tr>
              <a:tr h="151157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l-GR" sz="6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Δ</a:t>
                      </a:r>
                      <a:r>
                        <a:rPr lang="fr-FR" sz="6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aKmt1</a:t>
                      </a:r>
                    </a:p>
                  </a:txBody>
                  <a:tcPr marL="6722" marR="6722" marT="672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18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         -   </a:t>
                      </a:r>
                    </a:p>
                  </a:txBody>
                  <a:tcPr marL="6722" marR="6722" marT="672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         -   </a:t>
                      </a:r>
                    </a:p>
                  </a:txBody>
                  <a:tcPr marL="6722" marR="6722" marT="672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         -   </a:t>
                      </a:r>
                    </a:p>
                  </a:txBody>
                  <a:tcPr marL="6722" marR="6722" marT="672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         -   </a:t>
                      </a:r>
                    </a:p>
                  </a:txBody>
                  <a:tcPr marL="6722" marR="6722" marT="672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         -   </a:t>
                      </a:r>
                    </a:p>
                  </a:txBody>
                  <a:tcPr marL="6722" marR="6722" marT="672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         -   </a:t>
                      </a:r>
                    </a:p>
                  </a:txBody>
                  <a:tcPr marL="6722" marR="6722" marT="672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         -   </a:t>
                      </a:r>
                    </a:p>
                  </a:txBody>
                  <a:tcPr marL="6722" marR="6722" marT="672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         -   </a:t>
                      </a:r>
                    </a:p>
                  </a:txBody>
                  <a:tcPr marL="6722" marR="6722" marT="672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         -   </a:t>
                      </a:r>
                    </a:p>
                  </a:txBody>
                  <a:tcPr marL="6722" marR="6722" marT="672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14460966"/>
                  </a:ext>
                </a:extLst>
              </a:tr>
              <a:tr h="15871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l-GR" sz="6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Δ</a:t>
                      </a:r>
                      <a:r>
                        <a:rPr lang="fr-FR" sz="6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aKMT6</a:t>
                      </a:r>
                    </a:p>
                  </a:txBody>
                  <a:tcPr marL="6722" marR="6722" marT="672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B18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    0,06 </a:t>
                      </a:r>
                    </a:p>
                  </a:txBody>
                  <a:tcPr marL="6722" marR="6722" marT="672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8BF7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    0,18 </a:t>
                      </a:r>
                    </a:p>
                  </a:txBody>
                  <a:tcPr marL="6722" marR="6722" marT="672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8BF7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  85,00 </a:t>
                      </a:r>
                    </a:p>
                  </a:txBody>
                  <a:tcPr marL="6722" marR="6722" marT="672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CC07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    7,80 </a:t>
                      </a:r>
                    </a:p>
                  </a:txBody>
                  <a:tcPr marL="6722" marR="6722" marT="672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0C27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730,72 </a:t>
                      </a:r>
                    </a:p>
                  </a:txBody>
                  <a:tcPr marL="6722" marR="6722" marT="672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D98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  77,32 </a:t>
                      </a:r>
                    </a:p>
                  </a:txBody>
                  <a:tcPr marL="6722" marR="6722" marT="672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2E28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    2,00 </a:t>
                      </a:r>
                    </a:p>
                  </a:txBody>
                  <a:tcPr marL="6722" marR="6722" marT="672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129,00 </a:t>
                      </a:r>
                    </a:p>
                  </a:txBody>
                  <a:tcPr marL="6722" marR="6722" marT="672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88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    4,00 </a:t>
                      </a:r>
                    </a:p>
                  </a:txBody>
                  <a:tcPr marL="6722" marR="6722" marT="672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CC07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15077663"/>
                  </a:ext>
                </a:extLst>
              </a:tr>
              <a:tr h="158715"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fr-FR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3K27me3</a:t>
                      </a:r>
                    </a:p>
                  </a:txBody>
                  <a:tcPr marL="6722" marR="6722" marT="672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FAADC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6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T</a:t>
                      </a:r>
                    </a:p>
                  </a:txBody>
                  <a:tcPr marL="6722" marR="6722" marT="672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FAAD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    6,75 </a:t>
                      </a:r>
                    </a:p>
                  </a:txBody>
                  <a:tcPr marL="6722" marR="6722" marT="672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696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  19,28 </a:t>
                      </a:r>
                    </a:p>
                  </a:txBody>
                  <a:tcPr marL="6722" marR="6722" marT="672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696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1 941,00 </a:t>
                      </a:r>
                    </a:p>
                  </a:txBody>
                  <a:tcPr marL="6722" marR="6722" marT="672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EC87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100,00 </a:t>
                      </a:r>
                    </a:p>
                  </a:txBody>
                  <a:tcPr marL="6722" marR="6722" marT="672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AA7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3 476,75 </a:t>
                      </a:r>
                    </a:p>
                  </a:txBody>
                  <a:tcPr marL="6722" marR="6722" marT="672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696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100,00 </a:t>
                      </a:r>
                    </a:p>
                  </a:txBody>
                  <a:tcPr marL="6722" marR="6722" marT="672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28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2 992,00 </a:t>
                      </a:r>
                    </a:p>
                  </a:txBody>
                  <a:tcPr marL="6722" marR="6722" marT="672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957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1 042,00 </a:t>
                      </a:r>
                    </a:p>
                  </a:txBody>
                  <a:tcPr marL="6722" marR="6722" marT="672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696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307,00 </a:t>
                      </a:r>
                    </a:p>
                  </a:txBody>
                  <a:tcPr marL="6722" marR="6722" marT="672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696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05775346"/>
                  </a:ext>
                </a:extLst>
              </a:tr>
              <a:tr h="151157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l-GR" sz="6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Δ</a:t>
                      </a:r>
                      <a:r>
                        <a:rPr lang="fr-FR" sz="6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aHP1</a:t>
                      </a:r>
                    </a:p>
                  </a:txBody>
                  <a:tcPr marL="6722" marR="6722" marT="672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FAAD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    1,80 </a:t>
                      </a:r>
                    </a:p>
                  </a:txBody>
                  <a:tcPr marL="6722" marR="6722" marT="672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88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    5,15 </a:t>
                      </a:r>
                    </a:p>
                  </a:txBody>
                  <a:tcPr marL="6722" marR="6722" marT="672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88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1 443,00 </a:t>
                      </a:r>
                    </a:p>
                  </a:txBody>
                  <a:tcPr marL="6722" marR="6722" marT="672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88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  74,34 </a:t>
                      </a:r>
                    </a:p>
                  </a:txBody>
                  <a:tcPr marL="6722" marR="6722" marT="672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E48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1 250,34 </a:t>
                      </a:r>
                    </a:p>
                  </a:txBody>
                  <a:tcPr marL="6722" marR="6722" marT="672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88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  35,96 </a:t>
                      </a:r>
                    </a:p>
                  </a:txBody>
                  <a:tcPr marL="6722" marR="6722" marT="672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ECF7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1 027,00 </a:t>
                      </a:r>
                    </a:p>
                  </a:txBody>
                  <a:tcPr marL="6722" marR="6722" marT="672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8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551,00 </a:t>
                      </a:r>
                    </a:p>
                  </a:txBody>
                  <a:tcPr marL="6722" marR="6722" marT="672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AE7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239,00 </a:t>
                      </a:r>
                    </a:p>
                  </a:txBody>
                  <a:tcPr marL="6722" marR="6722" marT="672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8E7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31463817"/>
                  </a:ext>
                </a:extLst>
              </a:tr>
              <a:tr h="151157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l-GR" sz="6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Δ</a:t>
                      </a:r>
                      <a:r>
                        <a:rPr lang="fr-FR" sz="6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aKmt1</a:t>
                      </a:r>
                    </a:p>
                  </a:txBody>
                  <a:tcPr marL="6722" marR="6722" marT="672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FAAD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    1,56 </a:t>
                      </a:r>
                    </a:p>
                  </a:txBody>
                  <a:tcPr marL="6722" marR="6722" marT="672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3E78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    4,45 </a:t>
                      </a:r>
                    </a:p>
                  </a:txBody>
                  <a:tcPr marL="6722" marR="6722" marT="672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3E78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1 326,00 </a:t>
                      </a:r>
                    </a:p>
                  </a:txBody>
                  <a:tcPr marL="6722" marR="6722" marT="672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E98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  68,32 </a:t>
                      </a:r>
                    </a:p>
                  </a:txBody>
                  <a:tcPr marL="6722" marR="6722" marT="672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E18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1 174,28 </a:t>
                      </a:r>
                    </a:p>
                  </a:txBody>
                  <a:tcPr marL="6722" marR="6722" marT="672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EA8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  33,78 </a:t>
                      </a:r>
                    </a:p>
                  </a:txBody>
                  <a:tcPr marL="6722" marR="6722" marT="672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ACE7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1 003,00 </a:t>
                      </a:r>
                    </a:p>
                  </a:txBody>
                  <a:tcPr marL="6722" marR="6722" marT="672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DEA8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538,00 </a:t>
                      </a:r>
                    </a:p>
                  </a:txBody>
                  <a:tcPr marL="6722" marR="6722" marT="672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B07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259,00 </a:t>
                      </a:r>
                    </a:p>
                  </a:txBody>
                  <a:tcPr marL="6722" marR="6722" marT="672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837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97480092"/>
                  </a:ext>
                </a:extLst>
              </a:tr>
              <a:tr h="15871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l-GR" sz="6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Δ</a:t>
                      </a:r>
                      <a:r>
                        <a:rPr lang="fr-FR" sz="6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aKMT6</a:t>
                      </a:r>
                    </a:p>
                  </a:txBody>
                  <a:tcPr marL="6722" marR="6722" marT="672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FAAD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    0,01 </a:t>
                      </a:r>
                    </a:p>
                  </a:txBody>
                  <a:tcPr marL="6722" marR="6722" marT="672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4BE7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    0,04 </a:t>
                      </a:r>
                    </a:p>
                  </a:txBody>
                  <a:tcPr marL="6722" marR="6722" marT="672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4BE7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  47,00 </a:t>
                      </a:r>
                    </a:p>
                  </a:txBody>
                  <a:tcPr marL="6722" marR="6722" marT="672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8BF7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    2,42 </a:t>
                      </a:r>
                    </a:p>
                  </a:txBody>
                  <a:tcPr marL="6722" marR="6722" marT="672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7BF7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266,49 </a:t>
                      </a:r>
                    </a:p>
                  </a:txBody>
                  <a:tcPr marL="6722" marR="6722" marT="672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5C87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    7,66 </a:t>
                      </a:r>
                    </a:p>
                  </a:txBody>
                  <a:tcPr marL="6722" marR="6722" marT="672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FC17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  38,00 </a:t>
                      </a:r>
                    </a:p>
                  </a:txBody>
                  <a:tcPr marL="6722" marR="6722" marT="672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8BF7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         -   </a:t>
                      </a:r>
                    </a:p>
                  </a:txBody>
                  <a:tcPr marL="6722" marR="6722" marT="672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         -   </a:t>
                      </a:r>
                    </a:p>
                  </a:txBody>
                  <a:tcPr marL="6722" marR="6722" marT="672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46744384"/>
                  </a:ext>
                </a:extLst>
              </a:tr>
            </a:tbl>
          </a:graphicData>
        </a:graphic>
      </p:graphicFrame>
      <p:sp>
        <p:nvSpPr>
          <p:cNvPr id="2" name="ZoneTexte 1"/>
          <p:cNvSpPr txBox="1"/>
          <p:nvPr/>
        </p:nvSpPr>
        <p:spPr>
          <a:xfrm>
            <a:off x="259553" y="677333"/>
            <a:ext cx="9553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Table S1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88126841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9</TotalTime>
  <Words>290</Words>
  <Application>Microsoft Office PowerPoint</Application>
  <PresentationFormat>Format A4 (210 x 297 mm)</PresentationFormat>
  <Paragraphs>139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ierre GROGNET</dc:creator>
  <cp:lastModifiedBy>Pierre GROGNET</cp:lastModifiedBy>
  <cp:revision>13</cp:revision>
  <dcterms:created xsi:type="dcterms:W3CDTF">2019-09-13T16:44:35Z</dcterms:created>
  <dcterms:modified xsi:type="dcterms:W3CDTF">2020-08-20T13:48:37Z</dcterms:modified>
</cp:coreProperties>
</file>